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5" r:id="rId4"/>
    <p:sldId id="268" r:id="rId5"/>
    <p:sldId id="266" r:id="rId6"/>
    <p:sldId id="267" r:id="rId7"/>
    <p:sldId id="260" r:id="rId8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40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877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061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532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481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33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813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647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069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454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86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32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69A99-5E0E-4300-A1C1-0C19DFB1E7DA}" type="datetimeFigureOut">
              <a:rPr lang="en-US" smtClean="0"/>
              <a:t>10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911D6-9C3A-47C0-AAE0-9330DF9552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70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A0F5472-9289-4BD5-B9BC-7A8291757C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749" y="2123145"/>
            <a:ext cx="5079460" cy="187029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59749" y="1695260"/>
            <a:ext cx="5079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Table 1S: Deposited fractions of CB and CBox particles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372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F9712F5-628D-42F9-A911-FEF6C7920A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2439913"/>
              </p:ext>
            </p:extLst>
          </p:nvPr>
        </p:nvGraphicFramePr>
        <p:xfrm>
          <a:off x="482272" y="1966131"/>
          <a:ext cx="5893453" cy="223645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03049">
                  <a:extLst>
                    <a:ext uri="{9D8B030D-6E8A-4147-A177-3AD203B41FA5}">
                      <a16:colId xmlns:a16="http://schemas.microsoft.com/office/drawing/2014/main" val="1091677455"/>
                    </a:ext>
                  </a:extLst>
                </a:gridCol>
                <a:gridCol w="2161673">
                  <a:extLst>
                    <a:ext uri="{9D8B030D-6E8A-4147-A177-3AD203B41FA5}">
                      <a16:colId xmlns:a16="http://schemas.microsoft.com/office/drawing/2014/main" val="2242664803"/>
                    </a:ext>
                  </a:extLst>
                </a:gridCol>
                <a:gridCol w="2228731">
                  <a:extLst>
                    <a:ext uri="{9D8B030D-6E8A-4147-A177-3AD203B41FA5}">
                      <a16:colId xmlns:a16="http://schemas.microsoft.com/office/drawing/2014/main" val="4267200570"/>
                    </a:ext>
                  </a:extLst>
                </a:gridCol>
              </a:tblGrid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Sequence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Sequence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788653332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GAGTCATACGCATTCTG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GCATTCCCAGTGCCTTGGA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355966176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ACTTCACAAGTCGGAGG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CAAGTGCATCATCGTTGTTC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54685113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AGAGCTTGAAGGTGTTGC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AAGGGAGCTTCAGGGTC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385042732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β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CCTTCCAGGATGAGGACA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CATCTCGGAGCCTGTAGT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223690989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α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CCTATGTCTCAGCCTCTT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TAGAACTGATGAGAGGGA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542409409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0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ATCCCTGCGAGCCTATCCT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CTTTTTTGGCTAAACGCTTT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580037863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9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TCTGGAGATGACACCTGA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TTCCTCTGTCAGCATCAC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916428607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1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AGTAACGGCTGCGACAAA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CATTATGAGGCGAGCTT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06720829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B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GAAGTGCTCAGAGAGGTG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CTTGAACTTCTTTTTGGTCT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713655087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OS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CAGGGAAGTCTGAAGCA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GCAGTAGTTGCTCCTCTT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4059494536"/>
                  </a:ext>
                </a:extLst>
              </a:tr>
              <a:tr h="18637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CSF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TCCTGGATGACATGCCTG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TTGCCCCGTAGACCCTGCT</a:t>
                      </a:r>
                      <a:endParaRPr lang="en-U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43239524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12C4015-E29D-480E-906B-28B0EA7DFFB6}"/>
              </a:ext>
            </a:extLst>
          </p:cNvPr>
          <p:cNvSpPr txBox="1"/>
          <p:nvPr/>
        </p:nvSpPr>
        <p:spPr>
          <a:xfrm flipH="1">
            <a:off x="807876" y="1300480"/>
            <a:ext cx="5242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Table S2: Primer sequences for Real-time PCR</a:t>
            </a:r>
          </a:p>
        </p:txBody>
      </p:sp>
    </p:spTree>
    <p:extLst>
      <p:ext uri="{BB962C8B-B14F-4D97-AF65-F5344CB8AC3E}">
        <p14:creationId xmlns:p14="http://schemas.microsoft.com/office/powerpoint/2010/main" val="113907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6B8C0C72-491A-4F55-AFD7-89597B68A46A}"/>
              </a:ext>
            </a:extLst>
          </p:cNvPr>
          <p:cNvSpPr txBox="1"/>
          <p:nvPr/>
        </p:nvSpPr>
        <p:spPr>
          <a:xfrm>
            <a:off x="274038" y="7327159"/>
            <a:ext cx="62497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: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urface functional group alterations and Oxidant Generation on ozone interacted CB NPs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Fourier Transformed Infrared spectroscopy (FT-IR) analysis and, B) Deconvolution of O1s and C1s peaks of XPS data of CB and CBox powders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E1F5BBD-311D-4233-9B24-A110E80EB7AB}"/>
              </a:ext>
            </a:extLst>
          </p:cNvPr>
          <p:cNvSpPr txBox="1"/>
          <p:nvPr/>
        </p:nvSpPr>
        <p:spPr>
          <a:xfrm>
            <a:off x="1261127" y="9568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A78B95-F1CF-4FE5-94E3-95C31DDF4B25}"/>
              </a:ext>
            </a:extLst>
          </p:cNvPr>
          <p:cNvSpPr txBox="1"/>
          <p:nvPr/>
        </p:nvSpPr>
        <p:spPr>
          <a:xfrm>
            <a:off x="835283" y="33782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BEBB61C-6E19-4E99-970D-9C3475A042F2}"/>
              </a:ext>
            </a:extLst>
          </p:cNvPr>
          <p:cNvGrpSpPr/>
          <p:nvPr/>
        </p:nvGrpSpPr>
        <p:grpSpPr>
          <a:xfrm>
            <a:off x="1622613" y="956810"/>
            <a:ext cx="3552648" cy="2283297"/>
            <a:chOff x="953739" y="522739"/>
            <a:chExt cx="3552648" cy="2283297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3CE0D41-B8F2-4220-95D3-E45D56E726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3739" y="522739"/>
              <a:ext cx="3552648" cy="228329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9BBFED7-A50D-4697-8D3A-0E05C65219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4433" r="62309"/>
            <a:stretch/>
          </p:blipFill>
          <p:spPr>
            <a:xfrm>
              <a:off x="2870200" y="551773"/>
              <a:ext cx="413577" cy="202124"/>
            </a:xfrm>
            <a:prstGeom prst="rect">
              <a:avLst/>
            </a:prstGeom>
          </p:spPr>
        </p:pic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A8C0E59F-A7C5-4618-A61D-229655CC42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8891" y="3562947"/>
            <a:ext cx="2112649" cy="1828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8950E2D-401B-42B4-815A-CC78AC7A6F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8937" y="3407315"/>
            <a:ext cx="2112648" cy="183797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F56CFAD-B1DD-4189-8704-F2CA07F1AEA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97938" y="5476912"/>
            <a:ext cx="2231062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CC08FCA-7B2E-448A-8777-5264ECB13C5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3416" y="5412496"/>
            <a:ext cx="231368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775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22069" y="4716732"/>
            <a:ext cx="663593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Intracellular oxidant generation (dihydroethidium labeling) by flow cytometry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, pristine CB and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ox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eated RAW 264.7 cells, with or without EUK-134 pre-treatment. Data are presented as mean ± standard error of mean of three independent experiments with triplicates of each condition. Data analyzed by two-way ANOVA followed by Tukey’s post-hoc test. * p&lt;0.05 vs control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$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&lt;0.05 between without and with EUK-134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75" r="12497" b="11080"/>
          <a:stretch/>
        </p:blipFill>
        <p:spPr>
          <a:xfrm>
            <a:off x="1070500" y="431074"/>
            <a:ext cx="3880323" cy="35669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7BBAB32-480F-4A32-A6E3-60AD6079787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9230" b="-5029"/>
          <a:stretch/>
        </p:blipFill>
        <p:spPr>
          <a:xfrm>
            <a:off x="1070500" y="3998444"/>
            <a:ext cx="2846666" cy="677486"/>
          </a:xfrm>
          <a:prstGeom prst="rect">
            <a:avLst/>
          </a:prstGeom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AF2DE427-7978-4338-B31A-05115698380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697" t="43202" r="654" b="39917"/>
          <a:stretch/>
        </p:blipFill>
        <p:spPr>
          <a:xfrm>
            <a:off x="3917166" y="4039246"/>
            <a:ext cx="1318514" cy="506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02770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9572" y="461051"/>
            <a:ext cx="5234940" cy="29794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7BBAB32-480F-4A32-A6E3-60AD6079787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9230" b="-5029"/>
          <a:stretch/>
        </p:blipFill>
        <p:spPr>
          <a:xfrm>
            <a:off x="741012" y="3446302"/>
            <a:ext cx="2846666" cy="677486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AF2DE427-7978-4338-B31A-05115698380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697" t="43202" r="654" b="39917"/>
          <a:stretch/>
        </p:blipFill>
        <p:spPr>
          <a:xfrm>
            <a:off x="3679118" y="3531630"/>
            <a:ext cx="1318514" cy="50682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CA5DCE0-0E10-47B0-94BF-68ADE6B0F77D}"/>
              </a:ext>
            </a:extLst>
          </p:cNvPr>
          <p:cNvSpPr txBox="1"/>
          <p:nvPr/>
        </p:nvSpPr>
        <p:spPr>
          <a:xfrm>
            <a:off x="792479" y="4572000"/>
            <a:ext cx="541589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al-time PCR mRNA expression of inflammatory CXCL10 and CXCL11 with or without EUK-134 pre-treatment. Data are presented as mean ± standard error of mean of three independent experiments with triplicates of each condition. Data analyzed by two-way ANOVA followed by Tukey’s post-hoc test. * p&lt;0.05 vs control, # p&lt;0.05 between CB and CB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OX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, $ p&lt;0.05 between without and with EUK-134</a:t>
            </a:r>
          </a:p>
        </p:txBody>
      </p:sp>
    </p:spTree>
    <p:extLst>
      <p:ext uri="{BB962C8B-B14F-4D97-AF65-F5344CB8AC3E}">
        <p14:creationId xmlns:p14="http://schemas.microsoft.com/office/powerpoint/2010/main" val="971391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635" y="785403"/>
            <a:ext cx="4899660" cy="2948940"/>
          </a:xfrm>
          <a:prstGeom prst="rect">
            <a:avLst/>
          </a:prstGeom>
        </p:spPr>
      </p:pic>
      <p:pic>
        <p:nvPicPr>
          <p:cNvPr id="3" name="Picture 2" descr="A picture containing text, antenna&#10;&#10;Description automatically generated">
            <a:extLst>
              <a:ext uri="{FF2B5EF4-FFF2-40B4-BE49-F238E27FC236}">
                <a16:creationId xmlns:a16="http://schemas.microsoft.com/office/drawing/2014/main" id="{9139C36D-B8E1-48FD-AA7C-B32BFF1506B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46" t="1791" r="5996" b="89090"/>
          <a:stretch/>
        </p:blipFill>
        <p:spPr>
          <a:xfrm>
            <a:off x="780200" y="4151532"/>
            <a:ext cx="1454588" cy="265845"/>
          </a:xfrm>
          <a:prstGeom prst="rect">
            <a:avLst/>
          </a:prstGeom>
        </p:spPr>
      </p:pic>
      <p:pic>
        <p:nvPicPr>
          <p:cNvPr id="4" name="Picture 3" descr="A picture containing text, antenna&#10;&#10;Description automatically generated">
            <a:extLst>
              <a:ext uri="{FF2B5EF4-FFF2-40B4-BE49-F238E27FC236}">
                <a16:creationId xmlns:a16="http://schemas.microsoft.com/office/drawing/2014/main" id="{9139C36D-B8E1-48FD-AA7C-B32BFF1506B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46" t="11017" b="81618"/>
          <a:stretch/>
        </p:blipFill>
        <p:spPr>
          <a:xfrm>
            <a:off x="780200" y="4512595"/>
            <a:ext cx="1766236" cy="200025"/>
          </a:xfrm>
          <a:prstGeom prst="rect">
            <a:avLst/>
          </a:prstGeom>
        </p:spPr>
      </p:pic>
      <p:pic>
        <p:nvPicPr>
          <p:cNvPr id="5" name="Picture 4" descr="A picture containing text, antenna&#10;&#10;Description automatically generated">
            <a:extLst>
              <a:ext uri="{FF2B5EF4-FFF2-40B4-BE49-F238E27FC236}">
                <a16:creationId xmlns:a16="http://schemas.microsoft.com/office/drawing/2014/main" id="{9139C36D-B8E1-48FD-AA7C-B32BFF1506B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46" t="19083" b="73903"/>
          <a:stretch/>
        </p:blipFill>
        <p:spPr>
          <a:xfrm>
            <a:off x="2516199" y="4226222"/>
            <a:ext cx="1935173" cy="208722"/>
          </a:xfrm>
          <a:prstGeom prst="rect">
            <a:avLst/>
          </a:prstGeom>
        </p:spPr>
      </p:pic>
      <p:pic>
        <p:nvPicPr>
          <p:cNvPr id="6" name="Picture 5" descr="A picture containing text, antenna&#10;&#10;Description automatically generated">
            <a:extLst>
              <a:ext uri="{FF2B5EF4-FFF2-40B4-BE49-F238E27FC236}">
                <a16:creationId xmlns:a16="http://schemas.microsoft.com/office/drawing/2014/main" id="{9139C36D-B8E1-48FD-AA7C-B32BFF1506B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46" t="26799" b="66537"/>
          <a:stretch/>
        </p:blipFill>
        <p:spPr>
          <a:xfrm>
            <a:off x="2521051" y="4522119"/>
            <a:ext cx="1766236" cy="18097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E4DFA65-E38B-4081-BF76-D72C4CC9E4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30227" y="4492349"/>
            <a:ext cx="1783080" cy="2667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13A60EF-F4F6-48F9-8AA0-7609586AEA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46745" y="4177539"/>
            <a:ext cx="1013460" cy="2667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5022688-F0A4-4CAB-9907-ED46DA6621FA}"/>
              </a:ext>
            </a:extLst>
          </p:cNvPr>
          <p:cNvSpPr txBox="1"/>
          <p:nvPr/>
        </p:nvSpPr>
        <p:spPr>
          <a:xfrm>
            <a:off x="696219" y="4936118"/>
            <a:ext cx="541589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al-time PCR mRNA expression of inflammatory CXCL10 and CXCL11 with or without JNK inhibitor SPC600125 pre-treatment. Data are presented as mean ± standard error of mean of three independent experiments with triplicates of each condition. Data analyzed by two-way ANOVA followed by Tukey’s post-hoc test. * p&lt;0.05 vs control, # p&lt;0.05 between CB and CB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OX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, $ p&lt;0.05 between without and with SPC600125</a:t>
            </a:r>
          </a:p>
        </p:txBody>
      </p:sp>
    </p:spTree>
    <p:extLst>
      <p:ext uri="{BB962C8B-B14F-4D97-AF65-F5344CB8AC3E}">
        <p14:creationId xmlns:p14="http://schemas.microsoft.com/office/powerpoint/2010/main" val="30166881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8F03E81-3C80-44A3-8955-B0085FC94A39}"/>
              </a:ext>
            </a:extLst>
          </p:cNvPr>
          <p:cNvSpPr txBox="1"/>
          <p:nvPr/>
        </p:nvSpPr>
        <p:spPr>
          <a:xfrm>
            <a:off x="792479" y="4572000"/>
            <a:ext cx="541589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al-time PCR mRNA expression of inflammatory cytokines in Raw macrophages after 4 hours exposure with ozone reacted CB particles (5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 and CB particles (58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µg/mL and 50 µg/mL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Data are presented as mean ± standard error of mean of three independent experiments. Data analyzed by ANOV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llowed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O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Tukey’s post-hoc test. * p&lt;0.05 vs control, # p&lt;0.05 between CB and CB</a:t>
            </a:r>
            <a:endParaRPr lang="en-US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F6895C23-1C40-4B08-91BE-0CD21A82DA9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33" t="13268" b="55234"/>
          <a:stretch/>
        </p:blipFill>
        <p:spPr>
          <a:xfrm>
            <a:off x="4763626" y="935287"/>
            <a:ext cx="1444752" cy="93049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8AFDCB-4D7A-4226-AFB2-B489D6E360A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9767"/>
          <a:stretch/>
        </p:blipFill>
        <p:spPr>
          <a:xfrm>
            <a:off x="4672186" y="1874987"/>
            <a:ext cx="1214829" cy="28786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2019" y="2172056"/>
            <a:ext cx="5296436" cy="2364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0510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8</TotalTime>
  <Words>402</Words>
  <Application>Microsoft Office PowerPoint</Application>
  <PresentationFormat>Letter Paper (8.5x11 in)</PresentationFormat>
  <Paragraphs>4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rrita Majumder</dc:creator>
  <cp:lastModifiedBy>Hussain, Salik</cp:lastModifiedBy>
  <cp:revision>35</cp:revision>
  <cp:lastPrinted>2021-07-09T16:29:21Z</cp:lastPrinted>
  <dcterms:created xsi:type="dcterms:W3CDTF">2021-06-29T16:53:49Z</dcterms:created>
  <dcterms:modified xsi:type="dcterms:W3CDTF">2021-10-04T16:47:10Z</dcterms:modified>
</cp:coreProperties>
</file>